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0FAFC5-2534-4DFB-A4B3-180FE09E60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5770A-79E8-42CC-9A3B-451AE29E74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C4103-04B5-4390-B4BB-A2B321613B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353AD-B709-4081-A09B-DC7F62BB9D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4606F-C481-4799-8D8F-BBF3E9BED3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0D4C1-94B1-4435-8CA4-E76314CB2E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B4A9E6-5B16-4E6D-907D-807A1AE052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F566B1-95B2-4EB3-8822-F42B77985B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22759-10E1-4900-A918-53B63CA7D9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81FB0-55A3-4CBA-BC10-9CA45CA96C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873E2-4C6F-4E34-A6C5-8F28EC1C34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64D3D-7738-4805-AF22-D61E5F8952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585485-0466-4CFB-8107-2F1B97019A4C}" type="slidenum">
              <a:rPr b="0" lang="es-ES_tradn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1471680" y="1405080"/>
            <a:ext cx="6200640" cy="4047840"/>
          </a:xfrm>
          <a:prstGeom prst="rect">
            <a:avLst/>
          </a:prstGeom>
          <a:ln w="0">
            <a:noFill/>
          </a:ln>
        </p:spPr>
      </p:pic>
      <p:sp>
        <p:nvSpPr>
          <p:cNvPr id="42" name="6 CuadroTexto"/>
          <p:cNvSpPr/>
          <p:nvPr/>
        </p:nvSpPr>
        <p:spPr>
          <a:xfrm>
            <a:off x="1835280" y="1413000"/>
            <a:ext cx="79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M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7 CuadroTexto"/>
          <p:cNvSpPr/>
          <p:nvPr/>
        </p:nvSpPr>
        <p:spPr>
          <a:xfrm>
            <a:off x="2843280" y="1413000"/>
            <a:ext cx="79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Day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8 CuadroTexto"/>
          <p:cNvSpPr/>
          <p:nvPr/>
        </p:nvSpPr>
        <p:spPr>
          <a:xfrm>
            <a:off x="3924360" y="1413000"/>
            <a:ext cx="79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Day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9 CuadroTexto"/>
          <p:cNvSpPr/>
          <p:nvPr/>
        </p:nvSpPr>
        <p:spPr>
          <a:xfrm>
            <a:off x="5003640" y="1413000"/>
            <a:ext cx="79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Day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10 CuadroTexto"/>
          <p:cNvSpPr/>
          <p:nvPr/>
        </p:nvSpPr>
        <p:spPr>
          <a:xfrm>
            <a:off x="6012000" y="1413000"/>
            <a:ext cx="79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Day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7 CuadroTexto"/>
          <p:cNvSpPr/>
          <p:nvPr/>
        </p:nvSpPr>
        <p:spPr>
          <a:xfrm>
            <a:off x="971640" y="260280"/>
            <a:ext cx="7416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Fil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. Western blot of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. fasciculata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choanomastigote protein extracts throughout the growth curve for CACK detection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omplete image of the autoradiography.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"/>
          <p:cNvPicPr/>
          <p:nvPr/>
        </p:nvPicPr>
        <p:blipFill>
          <a:blip r:embed="rId1"/>
          <a:stretch/>
        </p:blipFill>
        <p:spPr>
          <a:xfrm>
            <a:off x="1461960" y="1442880"/>
            <a:ext cx="6134400" cy="3972240"/>
          </a:xfrm>
          <a:prstGeom prst="rect">
            <a:avLst/>
          </a:prstGeom>
          <a:ln w="0">
            <a:noFill/>
          </a:ln>
        </p:spPr>
      </p:pic>
      <p:sp>
        <p:nvSpPr>
          <p:cNvPr id="49" name="6 CuadroTexto"/>
          <p:cNvSpPr/>
          <p:nvPr/>
        </p:nvSpPr>
        <p:spPr>
          <a:xfrm>
            <a:off x="1835280" y="141300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M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7 CuadroTexto"/>
          <p:cNvSpPr/>
          <p:nvPr/>
        </p:nvSpPr>
        <p:spPr>
          <a:xfrm>
            <a:off x="2843280" y="141300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Day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8 CuadroTexto"/>
          <p:cNvSpPr/>
          <p:nvPr/>
        </p:nvSpPr>
        <p:spPr>
          <a:xfrm>
            <a:off x="3924360" y="1413000"/>
            <a:ext cx="8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Day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9 CuadroTexto"/>
          <p:cNvSpPr/>
          <p:nvPr/>
        </p:nvSpPr>
        <p:spPr>
          <a:xfrm>
            <a:off x="5003640" y="1413000"/>
            <a:ext cx="8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Day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10 CuadroTexto"/>
          <p:cNvSpPr/>
          <p:nvPr/>
        </p:nvSpPr>
        <p:spPr>
          <a:xfrm>
            <a:off x="6084720" y="1413000"/>
            <a:ext cx="8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ffffff"/>
                </a:solidFill>
                <a:latin typeface="Calibri"/>
                <a:ea typeface="Arial"/>
              </a:rPr>
              <a:t>Day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7 CuadroTexto"/>
          <p:cNvSpPr/>
          <p:nvPr/>
        </p:nvSpPr>
        <p:spPr>
          <a:xfrm>
            <a:off x="971640" y="590400"/>
            <a:ext cx="7416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. Western blot of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. fasciculata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choanomastigote protein extracts throughout the growth curve for gGAPDH detection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omplete image of the autoradiography.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01T07:01:47Z</dcterms:created>
  <dc:creator>Pedro</dc:creator>
  <dc:description/>
  <dc:language>en-US</dc:language>
  <cp:lastModifiedBy>pjalcolea@hotmail.com</cp:lastModifiedBy>
  <dcterms:modified xsi:type="dcterms:W3CDTF">2014-09-20T09:37:45Z</dcterms:modified>
  <cp:revision>4</cp:revision>
  <dc:subject/>
  <dc:title>Diapositiva 1</dc:title>
</cp:coreProperties>
</file>